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470" r:id="rId2"/>
    <p:sldId id="471" r:id="rId3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FADF6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0251445-9339-431E-8141-DBC253531CA4}" v="4" dt="2022-10-10T23:29:31.043"/>
  </p1510:revLst>
</p1510:revInfo>
</file>

<file path=ppt/tableStyles.xml><?xml version="1.0" encoding="utf-8"?>
<a:tblStyleLst xmlns:a="http://schemas.openxmlformats.org/drawingml/2006/main" def="{5C22544A-7EE6-4342-B048-85BDC9FD1C3A}">
  <a:tblStyle styleId="{9D7B26C5-4107-4FEC-AEDC-1716B250A1EF}" styleName="淡色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0E3FDE45-AF77-4B5C-9715-49D594BDF05E}" styleName="淡色 1 - アクセント 2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68D230F3-CF80-4859-8CE7-A43EE81993B5}" styleName="淡色 1 - アクセント 6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5FD0F851-EC5A-4D38-B0AD-8093EC10F338}" styleName="淡色 1 - アクセント 5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  <a:tblStyle styleId="{C083E6E3-FA7D-4D7B-A595-EF9225AFEA82}" styleName="淡色 1 - アクセント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2D5ABB26-0587-4C30-8999-92F81FD0307C}" styleName="スタイル/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8EC20E35-A176-4012-BC5E-935CFFF8708E}" styleName="中間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3B4B98B0-60AC-42C2-AFA5-B58CD77FA1E5}" styleName="淡色 1 - アクセント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30750" autoAdjust="0"/>
    <p:restoredTop sz="99804" autoAdjust="0"/>
  </p:normalViewPr>
  <p:slideViewPr>
    <p:cSldViewPr snapToGrid="0" snapToObjects="1">
      <p:cViewPr varScale="1">
        <p:scale>
          <a:sx n="127" d="100"/>
          <a:sy n="127" d="100"/>
        </p:scale>
        <p:origin x="872" y="17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hizuta Satoshi" userId="29a9164ecf10307e" providerId="LiveId" clId="{60251445-9339-431E-8141-DBC253531CA4}"/>
    <pc:docChg chg="undo custSel modSld">
      <pc:chgData name="Shizuta Satoshi" userId="29a9164ecf10307e" providerId="LiveId" clId="{60251445-9339-431E-8141-DBC253531CA4}" dt="2022-10-10T23:30:14.237" v="68" actId="20577"/>
      <pc:docMkLst>
        <pc:docMk/>
      </pc:docMkLst>
      <pc:sldChg chg="modSp mod">
        <pc:chgData name="Shizuta Satoshi" userId="29a9164ecf10307e" providerId="LiveId" clId="{60251445-9339-431E-8141-DBC253531CA4}" dt="2022-10-10T23:29:39.051" v="51" actId="404"/>
        <pc:sldMkLst>
          <pc:docMk/>
          <pc:sldMk cId="2116311448" sldId="470"/>
        </pc:sldMkLst>
        <pc:spChg chg="mod">
          <ac:chgData name="Shizuta Satoshi" userId="29a9164ecf10307e" providerId="LiveId" clId="{60251445-9339-431E-8141-DBC253531CA4}" dt="2022-10-10T23:28:08.499" v="26" actId="20577"/>
          <ac:spMkLst>
            <pc:docMk/>
            <pc:sldMk cId="2116311448" sldId="470"/>
            <ac:spMk id="30" creationId="{30CC19E7-9F45-2A42-8F3C-CE734D8046C2}"/>
          </ac:spMkLst>
        </pc:spChg>
        <pc:spChg chg="mod">
          <ac:chgData name="Shizuta Satoshi" userId="29a9164ecf10307e" providerId="LiveId" clId="{60251445-9339-431E-8141-DBC253531CA4}" dt="2022-10-10T23:28:05.998" v="25" actId="20577"/>
          <ac:spMkLst>
            <pc:docMk/>
            <pc:sldMk cId="2116311448" sldId="470"/>
            <ac:spMk id="58" creationId="{30CC19E7-9F45-2A42-8F3C-CE734D8046C2}"/>
          </ac:spMkLst>
        </pc:spChg>
        <pc:graphicFrameChg chg="mod modGraphic">
          <ac:chgData name="Shizuta Satoshi" userId="29a9164ecf10307e" providerId="LiveId" clId="{60251445-9339-431E-8141-DBC253531CA4}" dt="2022-10-10T23:29:06.708" v="46" actId="404"/>
          <ac:graphicFrameMkLst>
            <pc:docMk/>
            <pc:sldMk cId="2116311448" sldId="470"/>
            <ac:graphicFrameMk id="23" creationId="{F23A8846-D4A2-784F-B11E-FE538FEB57DA}"/>
          </ac:graphicFrameMkLst>
        </pc:graphicFrameChg>
        <pc:graphicFrameChg chg="mod modGraphic">
          <ac:chgData name="Shizuta Satoshi" userId="29a9164ecf10307e" providerId="LiveId" clId="{60251445-9339-431E-8141-DBC253531CA4}" dt="2022-10-10T23:29:39.051" v="51" actId="404"/>
          <ac:graphicFrameMkLst>
            <pc:docMk/>
            <pc:sldMk cId="2116311448" sldId="470"/>
            <ac:graphicFrameMk id="24" creationId="{5123B313-EA2F-BF44-8D6D-6B8426CA6C4C}"/>
          </ac:graphicFrameMkLst>
        </pc:graphicFrameChg>
        <pc:cxnChg chg="mod">
          <ac:chgData name="Shizuta Satoshi" userId="29a9164ecf10307e" providerId="LiveId" clId="{60251445-9339-431E-8141-DBC253531CA4}" dt="2022-10-10T23:27:41.676" v="21" actId="1037"/>
          <ac:cxnSpMkLst>
            <pc:docMk/>
            <pc:sldMk cId="2116311448" sldId="470"/>
            <ac:cxnSpMk id="34" creationId="{00000000-0000-0000-0000-000000000000}"/>
          </ac:cxnSpMkLst>
        </pc:cxnChg>
        <pc:cxnChg chg="mod">
          <ac:chgData name="Shizuta Satoshi" userId="29a9164ecf10307e" providerId="LiveId" clId="{60251445-9339-431E-8141-DBC253531CA4}" dt="2022-10-10T23:27:41.676" v="21" actId="1037"/>
          <ac:cxnSpMkLst>
            <pc:docMk/>
            <pc:sldMk cId="2116311448" sldId="470"/>
            <ac:cxnSpMk id="36" creationId="{00000000-0000-0000-0000-000000000000}"/>
          </ac:cxnSpMkLst>
        </pc:cxnChg>
      </pc:sldChg>
      <pc:sldChg chg="modSp mod">
        <pc:chgData name="Shizuta Satoshi" userId="29a9164ecf10307e" providerId="LiveId" clId="{60251445-9339-431E-8141-DBC253531CA4}" dt="2022-10-10T23:30:14.237" v="68" actId="20577"/>
        <pc:sldMkLst>
          <pc:docMk/>
          <pc:sldMk cId="1338342090" sldId="471"/>
        </pc:sldMkLst>
        <pc:graphicFrameChg chg="modGraphic">
          <ac:chgData name="Shizuta Satoshi" userId="29a9164ecf10307e" providerId="LiveId" clId="{60251445-9339-431E-8141-DBC253531CA4}" dt="2022-10-10T23:30:14.237" v="68" actId="20577"/>
          <ac:graphicFrameMkLst>
            <pc:docMk/>
            <pc:sldMk cId="1338342090" sldId="471"/>
            <ac:graphicFrameMk id="15" creationId="{00000000-0000-0000-0000-000000000000}"/>
          </ac:graphicFrameMkLst>
        </pc:graphicFrameChg>
      </pc:sldChg>
    </pc:docChg>
  </pc:docChgLst>
  <pc:docChgLst>
    <pc:chgData name="Shizuta Satoshi" userId="29a9164ecf10307e" providerId="LiveId" clId="{674332DA-BBFD-49EC-9B75-4994FC4F8352}"/>
    <pc:docChg chg="modSld">
      <pc:chgData name="Shizuta Satoshi" userId="29a9164ecf10307e" providerId="LiveId" clId="{674332DA-BBFD-49EC-9B75-4994FC4F8352}" dt="2022-10-11T21:44:40.721" v="26" actId="2711"/>
      <pc:docMkLst>
        <pc:docMk/>
      </pc:docMkLst>
      <pc:sldChg chg="modSp mod">
        <pc:chgData name="Shizuta Satoshi" userId="29a9164ecf10307e" providerId="LiveId" clId="{674332DA-BBFD-49EC-9B75-4994FC4F8352}" dt="2022-10-11T21:44:40.721" v="26" actId="2711"/>
        <pc:sldMkLst>
          <pc:docMk/>
          <pc:sldMk cId="1338342090" sldId="471"/>
        </pc:sldMkLst>
        <pc:spChg chg="mod">
          <ac:chgData name="Shizuta Satoshi" userId="29a9164ecf10307e" providerId="LiveId" clId="{674332DA-BBFD-49EC-9B75-4994FC4F8352}" dt="2022-10-11T21:44:40.721" v="26" actId="2711"/>
          <ac:spMkLst>
            <pc:docMk/>
            <pc:sldMk cId="1338342090" sldId="471"/>
            <ac:spMk id="24" creationId="{30CC19E7-9F45-2A42-8F3C-CE734D8046C2}"/>
          </ac:spMkLst>
        </pc:spChg>
        <pc:cxnChg chg="mod">
          <ac:chgData name="Shizuta Satoshi" userId="29a9164ecf10307e" providerId="LiveId" clId="{674332DA-BBFD-49EC-9B75-4994FC4F8352}" dt="2022-10-11T21:44:31.285" v="25" actId="1037"/>
          <ac:cxnSpMkLst>
            <pc:docMk/>
            <pc:sldMk cId="1338342090" sldId="471"/>
            <ac:cxnSpMk id="25" creationId="{00000000-0000-0000-0000-000000000000}"/>
          </ac:cxnSpMkLst>
        </pc:cxnChg>
        <pc:cxnChg chg="mod">
          <ac:chgData name="Shizuta Satoshi" userId="29a9164ecf10307e" providerId="LiveId" clId="{674332DA-BBFD-49EC-9B75-4994FC4F8352}" dt="2022-10-11T21:44:31.285" v="25" actId="1037"/>
          <ac:cxnSpMkLst>
            <pc:docMk/>
            <pc:sldMk cId="1338342090" sldId="471"/>
            <ac:cxnSpMk id="26" creationId="{00000000-0000-0000-0000-000000000000}"/>
          </ac:cxnSpMkLst>
        </pc:cxn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F2167A8-3DF8-CA4A-8BFC-2970A8E9CE82}" type="datetimeFigureOut">
              <a:rPr kumimoji="1" lang="ja-JP" altLang="en-US" smtClean="0"/>
              <a:t>2022/10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B76C7E-0997-0546-959E-A19113F1F9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28018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30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F2012-0C3A-1749-9089-BF2CDA32670A}" type="datetimeFigureOut">
              <a:rPr kumimoji="1" lang="ja-JP" altLang="en-US" smtClean="0"/>
              <a:t>2022/10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3C083-0342-5844-B157-6801B4EFDF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13654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F2012-0C3A-1749-9089-BF2CDA32670A}" type="datetimeFigureOut">
              <a:rPr kumimoji="1" lang="ja-JP" altLang="en-US" smtClean="0"/>
              <a:t>2022/10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3C083-0342-5844-B157-6801B4EFDF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99823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41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41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F2012-0C3A-1749-9089-BF2CDA32670A}" type="datetimeFigureOut">
              <a:rPr kumimoji="1" lang="ja-JP" altLang="en-US" smtClean="0"/>
              <a:t>2022/10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3C083-0342-5844-B157-6801B4EFDF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24776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F2012-0C3A-1749-9089-BF2CDA32670A}" type="datetimeFigureOut">
              <a:rPr kumimoji="1" lang="ja-JP" altLang="en-US" smtClean="0"/>
              <a:t>2022/10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3C083-0342-5844-B157-6801B4EFDF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4825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2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F2012-0C3A-1749-9089-BF2CDA32670A}" type="datetimeFigureOut">
              <a:rPr kumimoji="1" lang="ja-JP" altLang="en-US" smtClean="0"/>
              <a:t>2022/10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3C083-0342-5844-B157-6801B4EFDF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2959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F2012-0C3A-1749-9089-BF2CDA32670A}" type="datetimeFigureOut">
              <a:rPr kumimoji="1" lang="ja-JP" altLang="en-US" smtClean="0"/>
              <a:t>2022/10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3C083-0342-5844-B157-6801B4EFDF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78171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1" y="1535114"/>
            <a:ext cx="4040188" cy="63976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33" y="1535114"/>
            <a:ext cx="4041775" cy="63976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33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F2012-0C3A-1749-9089-BF2CDA32670A}" type="datetimeFigureOut">
              <a:rPr kumimoji="1" lang="ja-JP" altLang="en-US" smtClean="0"/>
              <a:t>2022/10/1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3C083-0342-5844-B157-6801B4EFDF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52742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F2012-0C3A-1749-9089-BF2CDA32670A}" type="datetimeFigureOut">
              <a:rPr kumimoji="1" lang="ja-JP" altLang="en-US" smtClean="0"/>
              <a:t>2022/10/1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3C083-0342-5844-B157-6801B4EFDF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90275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F2012-0C3A-1749-9089-BF2CDA32670A}" type="datetimeFigureOut">
              <a:rPr kumimoji="1" lang="ja-JP" altLang="en-US" smtClean="0"/>
              <a:t>2022/10/1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3C083-0342-5844-B157-6801B4EFDF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28795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8" y="273050"/>
            <a:ext cx="3008313" cy="11620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5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8" y="1435105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F2012-0C3A-1749-9089-BF2CDA32670A}" type="datetimeFigureOut">
              <a:rPr kumimoji="1" lang="ja-JP" altLang="en-US" smtClean="0"/>
              <a:t>2022/10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3C083-0342-5844-B157-6801B4EFDF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22064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2"/>
            <a:ext cx="5486400" cy="56673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42"/>
            <a:ext cx="5486400" cy="8048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F2012-0C3A-1749-9089-BF2CDA32670A}" type="datetimeFigureOut">
              <a:rPr kumimoji="1" lang="ja-JP" altLang="en-US" smtClean="0"/>
              <a:t>2022/10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3C083-0342-5844-B157-6801B4EFDF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56806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9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2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3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9F2012-0C3A-1749-9089-BF2CDA32670A}" type="datetimeFigureOut">
              <a:rPr kumimoji="1" lang="ja-JP" altLang="en-US" smtClean="0"/>
              <a:t>2022/10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3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3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E3C083-0342-5844-B157-6801B4EFDF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25726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テキスト ボックス 21"/>
          <p:cNvSpPr txBox="1"/>
          <p:nvPr/>
        </p:nvSpPr>
        <p:spPr>
          <a:xfrm>
            <a:off x="473153" y="273946"/>
            <a:ext cx="2659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Supplemental Figure 2</a:t>
            </a:r>
            <a:endParaRPr kumimoji="1" lang="ja-JP" altLang="en-US" b="1" dirty="0"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601567" y="683045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A)</a:t>
            </a:r>
            <a:endParaRPr kumimoji="1" lang="ja-JP" altLang="en-US" b="1" dirty="0"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  <p:graphicFrame>
        <p:nvGraphicFramePr>
          <p:cNvPr id="23" name="表 22">
            <a:extLst>
              <a:ext uri="{FF2B5EF4-FFF2-40B4-BE49-F238E27FC236}">
                <a16:creationId xmlns:a16="http://schemas.microsoft.com/office/drawing/2014/main" id="{F23A8846-D4A2-784F-B11E-FE538FEB57D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13018552"/>
              </p:ext>
            </p:extLst>
          </p:nvPr>
        </p:nvGraphicFramePr>
        <p:xfrm>
          <a:off x="95039" y="4948781"/>
          <a:ext cx="4411318" cy="1640205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46501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0740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7469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9105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49105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49105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49105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149634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rval</a:t>
                      </a:r>
                      <a:endParaRPr 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171451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-day</a:t>
                      </a:r>
                      <a:endParaRPr 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-month</a:t>
                      </a:r>
                      <a:endParaRPr 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-year</a:t>
                      </a:r>
                      <a:endParaRPr 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-year</a:t>
                      </a:r>
                      <a:endParaRPr 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-year</a:t>
                      </a:r>
                      <a:endParaRPr 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-year</a:t>
                      </a:r>
                      <a:endParaRPr 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4420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altLang="ja-JP" sz="800" b="1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revious</a:t>
                      </a:r>
                      <a:r>
                        <a:rPr lang="ja-JP" altLang="en-US" sz="800" b="1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800" b="1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F-related Complications</a:t>
                      </a:r>
                    </a:p>
                  </a:txBody>
                  <a:tcPr marL="171451" marR="9525" marT="9525" marB="0" anchor="ctr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tx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4420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of events</a:t>
                      </a:r>
                      <a:endParaRPr lang="en-US" sz="100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171451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0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8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5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8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9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4420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of patients at risk</a:t>
                      </a:r>
                      <a:endParaRPr lang="en-US" sz="100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171451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5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8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4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6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6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4420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Event free rate</a:t>
                      </a:r>
                      <a:endParaRPr lang="en-US" altLang="ja-JP" sz="1000" b="0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171451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.1%</a:t>
                      </a:r>
                      <a:endParaRPr lang="en-US" altLang="ja-JP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.4%</a:t>
                      </a:r>
                      <a:endParaRPr lang="en-US" altLang="ja-JP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.6%</a:t>
                      </a:r>
                      <a:endParaRPr lang="en-US" altLang="ja-JP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8%</a:t>
                      </a:r>
                      <a:endParaRPr lang="en-US" altLang="ja-JP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.9%</a:t>
                      </a:r>
                      <a:endParaRPr lang="en-US" altLang="ja-JP" sz="1000" b="1" i="0" u="none" strike="noStrike" dirty="0">
                        <a:solidFill>
                          <a:srgbClr val="C0504E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4420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altLang="ja-JP" sz="800" b="1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o previous AF-related complications</a:t>
                      </a:r>
                    </a:p>
                  </a:txBody>
                  <a:tcPr marL="171451" marR="9525" marT="9525" marB="0"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4420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of events</a:t>
                      </a:r>
                      <a:endParaRPr lang="en-US" sz="100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171451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5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6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9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62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62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4420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of patients at risk</a:t>
                      </a:r>
                      <a:endParaRPr lang="en-US" sz="100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171451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52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7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05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86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9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1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4420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Event free rate</a:t>
                      </a:r>
                      <a:endParaRPr lang="en-US" sz="1000" b="0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171451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7.0%</a:t>
                      </a:r>
                      <a:endParaRPr lang="en-US" altLang="ja-JP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9.7%</a:t>
                      </a:r>
                      <a:endParaRPr lang="en-US" altLang="ja-JP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.9%</a:t>
                      </a:r>
                      <a:endParaRPr lang="en-US" altLang="ja-JP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8.6%</a:t>
                      </a:r>
                      <a:endParaRPr lang="en-US" altLang="ja-JP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8.6%</a:t>
                      </a:r>
                      <a:endParaRPr lang="en-US" altLang="ja-JP" sz="1000" b="1" i="0" u="none" strike="noStrike" dirty="0">
                        <a:solidFill>
                          <a:srgbClr val="C0504E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</a:tbl>
          </a:graphicData>
        </a:graphic>
      </p:graphicFrame>
      <p:graphicFrame>
        <p:nvGraphicFramePr>
          <p:cNvPr id="24" name="表 23">
            <a:extLst>
              <a:ext uri="{FF2B5EF4-FFF2-40B4-BE49-F238E27FC236}">
                <a16:creationId xmlns:a16="http://schemas.microsoft.com/office/drawing/2014/main" id="{5123B313-EA2F-BF44-8D6D-6B8426CA6C4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59659052"/>
              </p:ext>
            </p:extLst>
          </p:nvPr>
        </p:nvGraphicFramePr>
        <p:xfrm>
          <a:off x="4588696" y="4948781"/>
          <a:ext cx="4411318" cy="1640205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37896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9345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7469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9105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49105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49105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49105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149634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rval</a:t>
                      </a:r>
                      <a:endParaRPr 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171451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-day</a:t>
                      </a:r>
                      <a:endParaRPr 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-month</a:t>
                      </a:r>
                      <a:endParaRPr 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-year</a:t>
                      </a:r>
                      <a:endParaRPr 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-year</a:t>
                      </a:r>
                      <a:endParaRPr 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-year</a:t>
                      </a:r>
                      <a:endParaRPr 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-year</a:t>
                      </a:r>
                      <a:endParaRPr 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4420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altLang="ja-JP" sz="800" b="1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revious</a:t>
                      </a:r>
                      <a:r>
                        <a:rPr lang="ja-JP" altLang="en-US" sz="800" b="1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800" b="1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F-related Complications</a:t>
                      </a:r>
                    </a:p>
                  </a:txBody>
                  <a:tcPr marL="171451" marR="9525" marT="9525" marB="0" anchor="ctr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tx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4420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of events</a:t>
                      </a:r>
                      <a:endParaRPr lang="en-US" sz="100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171451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6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9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2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4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4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4420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of patients at risk</a:t>
                      </a:r>
                      <a:endParaRPr lang="en-US" sz="100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171451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5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7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3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9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6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4420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Event free rate</a:t>
                      </a:r>
                      <a:endParaRPr lang="en-US" altLang="ja-JP" sz="1000" b="0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171451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8.9%</a:t>
                      </a:r>
                      <a:endParaRPr lang="en-US" altLang="ja-JP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3.2%</a:t>
                      </a:r>
                      <a:endParaRPr lang="en-US" altLang="ja-JP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7.4%</a:t>
                      </a:r>
                      <a:endParaRPr lang="en-US" altLang="ja-JP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.9%</a:t>
                      </a:r>
                      <a:endParaRPr lang="en-US" altLang="ja-JP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.9%</a:t>
                      </a:r>
                      <a:endParaRPr lang="en-US" altLang="ja-JP" sz="1000" b="1" i="0" u="none" strike="noStrike" dirty="0">
                        <a:solidFill>
                          <a:srgbClr val="C0504E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4420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altLang="ja-JP" sz="800" b="1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o previous AF-related complications</a:t>
                      </a:r>
                    </a:p>
                  </a:txBody>
                  <a:tcPr marL="171451" marR="9525" marT="9525" marB="0" anchor="ctr"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4420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of events</a:t>
                      </a:r>
                      <a:endParaRPr lang="en-US" sz="100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171451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2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5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3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7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8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4420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of patients at risk</a:t>
                      </a:r>
                      <a:endParaRPr lang="en-US" sz="100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171451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52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0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36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18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77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4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4420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Event free rate</a:t>
                      </a:r>
                      <a:endParaRPr lang="en-US" sz="1000" b="0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171451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.1%</a:t>
                      </a:r>
                      <a:endParaRPr lang="en-US" altLang="ja-JP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.1%</a:t>
                      </a:r>
                      <a:endParaRPr lang="en-US" altLang="ja-JP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4.7%</a:t>
                      </a:r>
                      <a:endParaRPr lang="en-US" altLang="ja-JP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1.6%</a:t>
                      </a:r>
                      <a:endParaRPr lang="en-US" altLang="ja-JP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8.8%</a:t>
                      </a:r>
                      <a:endParaRPr lang="en-US" altLang="ja-JP" sz="1000" b="1" i="0" u="none" strike="noStrike" dirty="0">
                        <a:solidFill>
                          <a:srgbClr val="C0504E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</a:tbl>
          </a:graphicData>
        </a:graphic>
      </p:graphicFrame>
      <p:pic>
        <p:nvPicPr>
          <p:cNvPr id="26" name="図 2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4299" y="2002728"/>
            <a:ext cx="4406900" cy="2882900"/>
          </a:xfrm>
          <a:prstGeom prst="rect">
            <a:avLst/>
          </a:prstGeom>
        </p:spPr>
      </p:pic>
      <p:sp>
        <p:nvSpPr>
          <p:cNvPr id="27" name="テキスト ボックス 26"/>
          <p:cNvSpPr txBox="1"/>
          <p:nvPr/>
        </p:nvSpPr>
        <p:spPr>
          <a:xfrm>
            <a:off x="1473655" y="1767621"/>
            <a:ext cx="2233304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After the first procedure</a:t>
            </a:r>
            <a:endParaRPr kumimoji="1" lang="en-US" altLang="ja-JP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30CC19E7-9F45-2A42-8F3C-CE734D8046C2}"/>
              </a:ext>
            </a:extLst>
          </p:cNvPr>
          <p:cNvSpPr txBox="1"/>
          <p:nvPr/>
        </p:nvSpPr>
        <p:spPr>
          <a:xfrm>
            <a:off x="1744539" y="2229839"/>
            <a:ext cx="2730235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b="1" dirty="0">
                <a:latin typeface="Arial"/>
                <a:cs typeface="Arial"/>
              </a:rPr>
              <a:t>Previous</a:t>
            </a:r>
            <a:r>
              <a:rPr lang="ja-JP" altLang="en-US" sz="1100" b="1">
                <a:latin typeface="Arial"/>
                <a:cs typeface="Arial"/>
              </a:rPr>
              <a:t> </a:t>
            </a:r>
            <a:r>
              <a:rPr lang="en-US" altLang="ja-JP" sz="1100" b="1" dirty="0">
                <a:latin typeface="Arial"/>
                <a:cs typeface="Arial"/>
              </a:rPr>
              <a:t>AF-related</a:t>
            </a:r>
            <a:r>
              <a:rPr lang="ja-JP" altLang="en-US" sz="1100" b="1">
                <a:latin typeface="Arial"/>
                <a:cs typeface="Arial"/>
              </a:rPr>
              <a:t> </a:t>
            </a:r>
            <a:r>
              <a:rPr lang="en-US" altLang="ja-JP" sz="1100" b="1" dirty="0">
                <a:latin typeface="Arial"/>
                <a:cs typeface="Arial"/>
              </a:rPr>
              <a:t>complications</a:t>
            </a:r>
          </a:p>
          <a:p>
            <a:r>
              <a:rPr lang="en-US" altLang="ja-JP" sz="1100" b="1" dirty="0">
                <a:latin typeface="Arial"/>
                <a:cs typeface="Arial"/>
              </a:rPr>
              <a:t>N</a:t>
            </a:r>
            <a:r>
              <a:rPr kumimoji="1" lang="en-US" altLang="ja-JP" sz="1100" b="1" dirty="0">
                <a:latin typeface="Arial"/>
                <a:cs typeface="Arial"/>
              </a:rPr>
              <a:t>o p</a:t>
            </a:r>
            <a:r>
              <a:rPr lang="en-US" altLang="ja-JP" sz="1100" b="1" dirty="0">
                <a:latin typeface="Arial"/>
                <a:cs typeface="Arial"/>
              </a:rPr>
              <a:t>revious</a:t>
            </a:r>
            <a:r>
              <a:rPr lang="ja-JP" altLang="en-US" sz="1100" b="1">
                <a:latin typeface="Arial"/>
                <a:cs typeface="Arial"/>
              </a:rPr>
              <a:t> </a:t>
            </a:r>
            <a:r>
              <a:rPr lang="en-US" altLang="ja-JP" sz="1100" b="1" dirty="0">
                <a:latin typeface="Arial"/>
                <a:cs typeface="Arial"/>
              </a:rPr>
              <a:t>AF-related</a:t>
            </a:r>
            <a:r>
              <a:rPr lang="ja-JP" altLang="en-US" sz="1100" b="1">
                <a:latin typeface="Arial"/>
                <a:cs typeface="Arial"/>
              </a:rPr>
              <a:t> </a:t>
            </a:r>
            <a:r>
              <a:rPr lang="en-US" altLang="ja-JP" sz="1100" b="1" dirty="0">
                <a:latin typeface="Arial"/>
                <a:cs typeface="Arial"/>
              </a:rPr>
              <a:t>complications</a:t>
            </a: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74E83AEE-31D5-0040-B203-FDF7E582C037}"/>
              </a:ext>
            </a:extLst>
          </p:cNvPr>
          <p:cNvSpPr txBox="1"/>
          <p:nvPr/>
        </p:nvSpPr>
        <p:spPr>
          <a:xfrm>
            <a:off x="1633618" y="3407424"/>
            <a:ext cx="2318007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Long-rank P</a:t>
            </a: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=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0.11</a:t>
            </a:r>
          </a:p>
          <a:p>
            <a:pPr algn="ctr"/>
            <a:r>
              <a:rPr lang="en-US" altLang="ja-JP" sz="1400" b="1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djusted HR </a:t>
            </a:r>
            <a:r>
              <a:rPr lang="ja-JP" altLang="ja-JP" sz="1400" b="1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ja-JP" sz="1400" b="1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.11, P=0.66</a:t>
            </a:r>
            <a:endParaRPr kumimoji="1" lang="en-US" altLang="ja-JP" sz="1400" b="1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直線コネクタ 31"/>
          <p:cNvCxnSpPr/>
          <p:nvPr/>
        </p:nvCxnSpPr>
        <p:spPr>
          <a:xfrm flipV="1">
            <a:off x="1069977" y="2119274"/>
            <a:ext cx="0" cy="2304000"/>
          </a:xfrm>
          <a:prstGeom prst="line">
            <a:avLst/>
          </a:prstGeom>
          <a:ln w="19050">
            <a:solidFill>
              <a:schemeClr val="bg1">
                <a:lumMod val="50000"/>
              </a:schemeClr>
            </a:solidFill>
            <a:prstDash val="sysDot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4" name="直線コネクタ 33"/>
          <p:cNvCxnSpPr/>
          <p:nvPr/>
        </p:nvCxnSpPr>
        <p:spPr>
          <a:xfrm flipV="1">
            <a:off x="1520223" y="2377221"/>
            <a:ext cx="215999" cy="353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6" name="直線コネクタ 35"/>
          <p:cNvCxnSpPr/>
          <p:nvPr/>
        </p:nvCxnSpPr>
        <p:spPr>
          <a:xfrm flipV="1">
            <a:off x="1526523" y="2542321"/>
            <a:ext cx="215999" cy="3530"/>
          </a:xfrm>
          <a:prstGeom prst="line">
            <a:avLst/>
          </a:prstGeom>
          <a:ln>
            <a:solidFill>
              <a:schemeClr val="tx1"/>
            </a:solidFill>
            <a:prstDash val="sys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40" name="図 3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15513" y="2006600"/>
            <a:ext cx="4356100" cy="2882900"/>
          </a:xfrm>
          <a:prstGeom prst="rect">
            <a:avLst/>
          </a:prstGeom>
        </p:spPr>
      </p:pic>
      <p:sp>
        <p:nvSpPr>
          <p:cNvPr id="43" name="テキスト ボックス 42"/>
          <p:cNvSpPr txBox="1"/>
          <p:nvPr/>
        </p:nvSpPr>
        <p:spPr>
          <a:xfrm>
            <a:off x="6047695" y="1771151"/>
            <a:ext cx="2202846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After the l</a:t>
            </a:r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ast procedure</a:t>
            </a: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AECB6143-1668-2F4D-B746-E2372CB3BE02}"/>
              </a:ext>
            </a:extLst>
          </p:cNvPr>
          <p:cNvSpPr txBox="1"/>
          <p:nvPr/>
        </p:nvSpPr>
        <p:spPr>
          <a:xfrm>
            <a:off x="5985178" y="3377048"/>
            <a:ext cx="232788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Long-rank P</a:t>
            </a: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=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0.21</a:t>
            </a:r>
          </a:p>
          <a:p>
            <a:pPr algn="ctr"/>
            <a:r>
              <a:rPr lang="en-US" altLang="ja-JP" sz="1400" b="1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djusted HR </a:t>
            </a:r>
            <a:r>
              <a:rPr lang="ja-JP" altLang="ja-JP" sz="1400" b="1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ja-JP" sz="1400" b="1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.19, P=0.62</a:t>
            </a:r>
            <a:endParaRPr kumimoji="1" lang="en-US" altLang="ja-JP" sz="1400" b="1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7" name="直線コネクタ 56"/>
          <p:cNvCxnSpPr/>
          <p:nvPr/>
        </p:nvCxnSpPr>
        <p:spPr>
          <a:xfrm flipV="1">
            <a:off x="5535742" y="2119274"/>
            <a:ext cx="0" cy="2304000"/>
          </a:xfrm>
          <a:prstGeom prst="line">
            <a:avLst/>
          </a:prstGeom>
          <a:ln w="19050">
            <a:solidFill>
              <a:schemeClr val="bg1">
                <a:lumMod val="50000"/>
              </a:schemeClr>
            </a:solidFill>
            <a:prstDash val="sysDot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30CC19E7-9F45-2A42-8F3C-CE734D8046C2}"/>
              </a:ext>
            </a:extLst>
          </p:cNvPr>
          <p:cNvSpPr txBox="1"/>
          <p:nvPr/>
        </p:nvSpPr>
        <p:spPr>
          <a:xfrm>
            <a:off x="6087242" y="2793104"/>
            <a:ext cx="286201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/>
                <a:cs typeface="Arial"/>
              </a:rPr>
              <a:t>Previous</a:t>
            </a:r>
            <a:r>
              <a:rPr lang="ja-JP" altLang="en-US" sz="1100" b="1">
                <a:latin typeface="Arial"/>
                <a:cs typeface="Arial"/>
              </a:rPr>
              <a:t> </a:t>
            </a:r>
            <a:r>
              <a:rPr lang="en-US" altLang="ja-JP" sz="1100" b="1" dirty="0">
                <a:latin typeface="Arial"/>
                <a:cs typeface="Arial"/>
              </a:rPr>
              <a:t>AF-related</a:t>
            </a:r>
            <a:r>
              <a:rPr lang="ja-JP" altLang="en-US" sz="1100" b="1">
                <a:latin typeface="Arial"/>
                <a:cs typeface="Arial"/>
              </a:rPr>
              <a:t> </a:t>
            </a:r>
            <a:r>
              <a:rPr lang="en-US" altLang="ja-JP" sz="1100" b="1" dirty="0">
                <a:latin typeface="Arial"/>
                <a:cs typeface="Arial"/>
              </a:rPr>
              <a:t>complications</a:t>
            </a:r>
          </a:p>
          <a:p>
            <a:r>
              <a:rPr lang="en-US" altLang="ja-JP" sz="1100" b="1" dirty="0">
                <a:latin typeface="Arial"/>
                <a:cs typeface="Arial"/>
              </a:rPr>
              <a:t>N</a:t>
            </a:r>
            <a:r>
              <a:rPr kumimoji="1" lang="en-US" altLang="ja-JP" sz="1100" b="1" dirty="0">
                <a:latin typeface="Arial"/>
                <a:cs typeface="Arial"/>
              </a:rPr>
              <a:t>o </a:t>
            </a:r>
            <a:r>
              <a:rPr lang="en-US" altLang="ja-JP" sz="1100" b="1" dirty="0">
                <a:latin typeface="Arial"/>
                <a:cs typeface="Arial"/>
              </a:rPr>
              <a:t>previous</a:t>
            </a:r>
            <a:r>
              <a:rPr lang="ja-JP" altLang="en-US" sz="1100" b="1">
                <a:latin typeface="Arial"/>
                <a:cs typeface="Arial"/>
              </a:rPr>
              <a:t> </a:t>
            </a:r>
            <a:r>
              <a:rPr lang="en-US" altLang="ja-JP" sz="1100" b="1" dirty="0">
                <a:latin typeface="Arial"/>
                <a:cs typeface="Arial"/>
              </a:rPr>
              <a:t>AF-related</a:t>
            </a:r>
            <a:r>
              <a:rPr lang="ja-JP" altLang="en-US" sz="1100" b="1">
                <a:latin typeface="Arial"/>
                <a:cs typeface="Arial"/>
              </a:rPr>
              <a:t> </a:t>
            </a:r>
            <a:r>
              <a:rPr lang="en-US" altLang="ja-JP" sz="1100" b="1" dirty="0">
                <a:latin typeface="Arial"/>
                <a:cs typeface="Arial"/>
              </a:rPr>
              <a:t>complications</a:t>
            </a:r>
          </a:p>
        </p:txBody>
      </p:sp>
      <p:cxnSp>
        <p:nvCxnSpPr>
          <p:cNvPr id="59" name="直線コネクタ 58"/>
          <p:cNvCxnSpPr/>
          <p:nvPr/>
        </p:nvCxnSpPr>
        <p:spPr>
          <a:xfrm flipV="1">
            <a:off x="5881642" y="2940486"/>
            <a:ext cx="215999" cy="353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0" name="直線コネクタ 59"/>
          <p:cNvCxnSpPr/>
          <p:nvPr/>
        </p:nvCxnSpPr>
        <p:spPr>
          <a:xfrm flipV="1">
            <a:off x="5887942" y="3105586"/>
            <a:ext cx="215999" cy="3530"/>
          </a:xfrm>
          <a:prstGeom prst="line">
            <a:avLst/>
          </a:prstGeom>
          <a:ln>
            <a:solidFill>
              <a:schemeClr val="tx1"/>
            </a:solidFill>
            <a:prstDash val="sys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00A09C2F-C451-1F47-8FDB-1BED9FEE04B4}"/>
              </a:ext>
            </a:extLst>
          </p:cNvPr>
          <p:cNvSpPr txBox="1"/>
          <p:nvPr/>
        </p:nvSpPr>
        <p:spPr>
          <a:xfrm>
            <a:off x="1267935" y="4524705"/>
            <a:ext cx="3429144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1           2          3           4           5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         6           7          8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549D313A-2375-1146-A1E6-CED2317511FE}"/>
              </a:ext>
            </a:extLst>
          </p:cNvPr>
          <p:cNvSpPr txBox="1"/>
          <p:nvPr/>
        </p:nvSpPr>
        <p:spPr>
          <a:xfrm>
            <a:off x="2247109" y="4702930"/>
            <a:ext cx="1021433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Interval [years]</a:t>
            </a:r>
            <a:endParaRPr kumimoji="1" lang="ja-JP" altLang="en-US" sz="1000" dirty="0"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7A2DB635-8AA4-C14B-9D98-012F384F15A4}"/>
              </a:ext>
            </a:extLst>
          </p:cNvPr>
          <p:cNvSpPr txBox="1"/>
          <p:nvPr/>
        </p:nvSpPr>
        <p:spPr>
          <a:xfrm>
            <a:off x="5737205" y="4524705"/>
            <a:ext cx="3429144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1           2          3           4           5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         6           7          8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C44F1E8B-BB26-6D44-986F-E1EFC983E0A5}"/>
              </a:ext>
            </a:extLst>
          </p:cNvPr>
          <p:cNvSpPr txBox="1"/>
          <p:nvPr/>
        </p:nvSpPr>
        <p:spPr>
          <a:xfrm>
            <a:off x="6716379" y="4702930"/>
            <a:ext cx="1021433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Interval [years]</a:t>
            </a:r>
            <a:endParaRPr kumimoji="1" lang="ja-JP" altLang="en-US" sz="1000" dirty="0"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B62F5317-C134-D742-BF92-AF8D804AA390}"/>
              </a:ext>
            </a:extLst>
          </p:cNvPr>
          <p:cNvSpPr txBox="1"/>
          <p:nvPr/>
        </p:nvSpPr>
        <p:spPr>
          <a:xfrm rot="16200000">
            <a:off x="-349699" y="3183364"/>
            <a:ext cx="1330814" cy="25391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Event  free survival</a:t>
            </a:r>
            <a:endParaRPr kumimoji="1" lang="ja-JP" altLang="en-US" sz="1050" dirty="0"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C9333BB2-3FA6-7340-A4DC-281203461190}"/>
              </a:ext>
            </a:extLst>
          </p:cNvPr>
          <p:cNvSpPr txBox="1"/>
          <p:nvPr/>
        </p:nvSpPr>
        <p:spPr>
          <a:xfrm rot="16200000">
            <a:off x="4122162" y="3179751"/>
            <a:ext cx="1330814" cy="25391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Event free  survival</a:t>
            </a:r>
            <a:endParaRPr kumimoji="1" lang="ja-JP" altLang="en-US" sz="1050" dirty="0"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163114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テキスト ボックス 9"/>
          <p:cNvSpPr txBox="1"/>
          <p:nvPr/>
        </p:nvSpPr>
        <p:spPr>
          <a:xfrm>
            <a:off x="601567" y="683045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B)</a:t>
            </a:r>
            <a:endParaRPr kumimoji="1" lang="ja-JP" altLang="en-US" b="1" dirty="0"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  <p:graphicFrame>
        <p:nvGraphicFramePr>
          <p:cNvPr id="15" name="表 1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88071385"/>
              </p:ext>
            </p:extLst>
          </p:nvPr>
        </p:nvGraphicFramePr>
        <p:xfrm>
          <a:off x="2101457" y="4631802"/>
          <a:ext cx="4489413" cy="1641493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49095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1462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8486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9974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499743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499743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499743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162247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rval</a:t>
                      </a:r>
                      <a:endParaRPr 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171451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-day</a:t>
                      </a:r>
                      <a:endParaRPr 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-month</a:t>
                      </a:r>
                      <a:endParaRPr 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-year</a:t>
                      </a:r>
                      <a:endParaRPr 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-year</a:t>
                      </a:r>
                      <a:endParaRPr 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-year</a:t>
                      </a:r>
                      <a:endParaRPr 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-year</a:t>
                      </a:r>
                      <a:endParaRPr 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62247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altLang="ja-JP" sz="800" b="1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revious</a:t>
                      </a:r>
                      <a:r>
                        <a:rPr lang="ja-JP" altLang="en-US" sz="800" b="1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800" b="1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F-related Complications</a:t>
                      </a:r>
                    </a:p>
                  </a:txBody>
                  <a:tcPr marL="171451" marR="9525" marT="9525" marB="0" anchor="ctr"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00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62247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of events</a:t>
                      </a:r>
                      <a:endParaRPr lang="en-US" sz="100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171451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8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5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5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5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62247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of patients at risk</a:t>
                      </a:r>
                      <a:endParaRPr lang="en-US" sz="100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171451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5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2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5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5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6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8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62247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Event free rate</a:t>
                      </a:r>
                      <a:endParaRPr lang="en-US" altLang="ja-JP" sz="1000" b="0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171451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%</a:t>
                      </a:r>
                      <a:endParaRPr lang="en-US" altLang="ja-JP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1%</a:t>
                      </a:r>
                      <a:endParaRPr lang="en-US" altLang="ja-JP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.5%</a:t>
                      </a:r>
                      <a:endParaRPr lang="en-US" altLang="ja-JP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.5%</a:t>
                      </a:r>
                      <a:endParaRPr lang="en-US" altLang="ja-JP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.5%</a:t>
                      </a:r>
                      <a:endParaRPr lang="en-US" altLang="ja-JP" sz="1000" b="1" i="0" u="none" strike="noStrike" dirty="0">
                        <a:solidFill>
                          <a:srgbClr val="C0504E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1511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altLang="ja-JP" sz="800" b="1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o previous AF-related complications</a:t>
                      </a:r>
                    </a:p>
                  </a:txBody>
                  <a:tcPr marL="171451" marR="9525" marT="9525" marB="0"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1511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of events</a:t>
                      </a:r>
                      <a:endParaRPr lang="en-US" sz="100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171451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6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9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73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76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78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1511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of patients at risk</a:t>
                      </a:r>
                      <a:endParaRPr lang="en-US" sz="100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171451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52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8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04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71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3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</a:t>
                      </a:r>
                      <a:endParaRPr lang="en-US" altLang="ja-JP" sz="100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1511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Event free rate</a:t>
                      </a:r>
                      <a:endParaRPr lang="en-US" sz="1000" b="0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171451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.1%</a:t>
                      </a:r>
                      <a:endParaRPr lang="en-US" altLang="ja-JP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.2%</a:t>
                      </a:r>
                      <a:endParaRPr lang="en-US" altLang="ja-JP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.4%</a:t>
                      </a:r>
                      <a:endParaRPr lang="en-US" altLang="ja-JP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.0%</a:t>
                      </a:r>
                      <a:endParaRPr lang="en-US" altLang="ja-JP" sz="100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.8%</a:t>
                      </a:r>
                      <a:endParaRPr lang="en-US" altLang="ja-JP" sz="1000" b="1" i="0" u="none" strike="noStrike" dirty="0">
                        <a:solidFill>
                          <a:srgbClr val="C0504E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pic>
        <p:nvPicPr>
          <p:cNvPr id="20" name="図 1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54149" y="1580558"/>
            <a:ext cx="4406900" cy="2882900"/>
          </a:xfrm>
          <a:prstGeom prst="rect">
            <a:avLst/>
          </a:prstGeom>
        </p:spPr>
      </p:pic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03977845-4C01-434E-A908-A480A1E1ADF5}"/>
              </a:ext>
            </a:extLst>
          </p:cNvPr>
          <p:cNvSpPr txBox="1"/>
          <p:nvPr/>
        </p:nvSpPr>
        <p:spPr>
          <a:xfrm>
            <a:off x="3813263" y="3428207"/>
            <a:ext cx="232788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Long-rank P=0.00</a:t>
            </a:r>
            <a:r>
              <a:rPr lang="ja-JP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en-US" altLang="ja-JP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1400" b="1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djusted HR 0.50, P=0.02</a:t>
            </a:r>
            <a:endParaRPr kumimoji="1" lang="en-US" altLang="ja-JP" sz="1400" b="1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30CC19E7-9F45-2A42-8F3C-CE734D8046C2}"/>
              </a:ext>
            </a:extLst>
          </p:cNvPr>
          <p:cNvSpPr txBox="1"/>
          <p:nvPr/>
        </p:nvSpPr>
        <p:spPr>
          <a:xfrm>
            <a:off x="3606763" y="1891209"/>
            <a:ext cx="2730235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b="1" dirty="0">
                <a:latin typeface="Arial"/>
                <a:cs typeface="Arial"/>
              </a:rPr>
              <a:t>Previous</a:t>
            </a:r>
            <a:r>
              <a:rPr lang="ja-JP" altLang="en-US" sz="1100" b="1">
                <a:latin typeface="Arial"/>
                <a:cs typeface="Arial"/>
              </a:rPr>
              <a:t> </a:t>
            </a:r>
            <a:r>
              <a:rPr lang="en-US" altLang="ja-JP" sz="1100" b="1" dirty="0">
                <a:latin typeface="Arial"/>
                <a:cs typeface="Arial"/>
              </a:rPr>
              <a:t>AF-related complications</a:t>
            </a:r>
          </a:p>
          <a:p>
            <a:r>
              <a:rPr lang="en-US" altLang="ja-JP" sz="1100" b="1" dirty="0">
                <a:latin typeface="Arial"/>
                <a:cs typeface="Arial"/>
              </a:rPr>
              <a:t>N</a:t>
            </a:r>
            <a:r>
              <a:rPr kumimoji="1" lang="en-US" altLang="ja-JP" sz="1100" b="1" dirty="0">
                <a:latin typeface="Arial"/>
                <a:cs typeface="Arial"/>
              </a:rPr>
              <a:t>o p</a:t>
            </a:r>
            <a:r>
              <a:rPr lang="en-US" altLang="ja-JP" sz="1100" b="1" dirty="0">
                <a:latin typeface="Arial"/>
                <a:cs typeface="Arial"/>
              </a:rPr>
              <a:t>revious</a:t>
            </a:r>
            <a:r>
              <a:rPr lang="ja-JP" altLang="en-US" sz="1100" b="1">
                <a:latin typeface="Arial"/>
                <a:cs typeface="Arial"/>
              </a:rPr>
              <a:t> </a:t>
            </a:r>
            <a:r>
              <a:rPr lang="en-US" altLang="ja-JP" sz="1100" b="1" dirty="0">
                <a:latin typeface="Arial"/>
                <a:cs typeface="Arial"/>
              </a:rPr>
              <a:t>AF-related complications</a:t>
            </a:r>
          </a:p>
        </p:txBody>
      </p:sp>
      <p:cxnSp>
        <p:nvCxnSpPr>
          <p:cNvPr id="25" name="直線コネクタ 24"/>
          <p:cNvCxnSpPr/>
          <p:nvPr/>
        </p:nvCxnSpPr>
        <p:spPr>
          <a:xfrm flipV="1">
            <a:off x="3401162" y="2038591"/>
            <a:ext cx="215999" cy="353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" name="直線コネクタ 25"/>
          <p:cNvCxnSpPr/>
          <p:nvPr/>
        </p:nvCxnSpPr>
        <p:spPr>
          <a:xfrm flipV="1">
            <a:off x="3407462" y="2203691"/>
            <a:ext cx="215999" cy="3530"/>
          </a:xfrm>
          <a:prstGeom prst="line">
            <a:avLst/>
          </a:prstGeom>
          <a:ln>
            <a:solidFill>
              <a:schemeClr val="tx1"/>
            </a:solidFill>
            <a:prstDash val="sys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6E4225D2-D9FD-1F42-8707-2D27A0911EA5}"/>
              </a:ext>
            </a:extLst>
          </p:cNvPr>
          <p:cNvSpPr txBox="1"/>
          <p:nvPr/>
        </p:nvSpPr>
        <p:spPr>
          <a:xfrm>
            <a:off x="3093462" y="4110534"/>
            <a:ext cx="3429144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1           2          3           4           5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         6           7          8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EA296802-D23F-0F4A-A09A-FBB4095FF571}"/>
              </a:ext>
            </a:extLst>
          </p:cNvPr>
          <p:cNvSpPr txBox="1"/>
          <p:nvPr/>
        </p:nvSpPr>
        <p:spPr>
          <a:xfrm>
            <a:off x="4072636" y="4288759"/>
            <a:ext cx="1021433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Interval [years]</a:t>
            </a:r>
            <a:endParaRPr kumimoji="1" lang="ja-JP" altLang="en-US" sz="1000" dirty="0"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AD39BFD3-F16B-9243-96A2-17188DC433A2}"/>
              </a:ext>
            </a:extLst>
          </p:cNvPr>
          <p:cNvSpPr txBox="1"/>
          <p:nvPr/>
        </p:nvSpPr>
        <p:spPr>
          <a:xfrm rot="16200000">
            <a:off x="1484368" y="2773040"/>
            <a:ext cx="1398140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Cumulative incidence</a:t>
            </a:r>
            <a:endParaRPr kumimoji="1" lang="ja-JP" altLang="en-US" sz="1000" dirty="0"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38342090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Perception">
      <a:majorFont>
        <a:latin typeface="Century Gothic"/>
        <a:ea typeface=""/>
        <a:cs typeface=""/>
        <a:font script="Jpan" typeface="メイリオ"/>
        <a:font script="Hans" typeface="宋体"/>
        <a:font script="Hant" typeface="新細明體"/>
      </a:majorFont>
      <a:minorFont>
        <a:latin typeface="Century Gothic"/>
        <a:ea typeface=""/>
        <a:cs typeface=""/>
        <a:font script="Jpan" typeface="メイリオ"/>
        <a:font script="Hans" typeface="宋体"/>
        <a:font script="Hant" typeface="新細明體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448</TotalTime>
  <Words>387</Words>
  <Application>Microsoft Macintosh PowerPoint</Application>
  <PresentationFormat>画面に合わせる (4:3)</PresentationFormat>
  <Paragraphs>203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6" baseType="lpstr">
      <vt:lpstr>Arial</vt:lpstr>
      <vt:lpstr>Calibri</vt:lpstr>
      <vt:lpstr>Century Gothic</vt:lpstr>
      <vt:lpstr>ホワイト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FCA for AF in Kyoto Graduate School of Medicine between 2004/2 and 2015/3</dc:title>
  <dc:creator>川治 徹真</dc:creator>
  <cp:lastModifiedBy>Microsoft Office User</cp:lastModifiedBy>
  <cp:revision>744</cp:revision>
  <cp:lastPrinted>2018-10-30T23:44:42Z</cp:lastPrinted>
  <dcterms:created xsi:type="dcterms:W3CDTF">2016-09-15T07:16:03Z</dcterms:created>
  <dcterms:modified xsi:type="dcterms:W3CDTF">2022-10-13T21:59:30Z</dcterms:modified>
</cp:coreProperties>
</file>